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42" r:id="rId2"/>
    <p:sldId id="343" r:id="rId3"/>
    <p:sldId id="346" r:id="rId4"/>
    <p:sldId id="345" r:id="rId5"/>
    <p:sldId id="272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4" d="100"/>
          <a:sy n="64" d="100"/>
        </p:scale>
        <p:origin x="68" y="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tr-T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837877350021801"/>
          <c:y val="0.21795151100183624"/>
          <c:w val="0.82703937007874018"/>
          <c:h val="0.68921660834062404"/>
        </c:manualLayout>
      </c:layout>
      <c:lineChart>
        <c:grouping val="standard"/>
        <c:varyColors val="0"/>
        <c:ser>
          <c:idx val="0"/>
          <c:order val="0"/>
          <c:tx>
            <c:strRef>
              <c:f>Sheet1!$I$10:$I$11</c:f>
              <c:strCache>
                <c:ptCount val="2"/>
                <c:pt idx="0">
                  <c:v>CAT-S Cell Growth Curve</c:v>
                </c:pt>
                <c:pt idx="1">
                  <c:v>(cell /ml)</c:v>
                </c:pt>
              </c:strCache>
            </c:strRef>
          </c:tx>
          <c:cat>
            <c:strRef>
              <c:f>Sheet1!$B$12:$B$16</c:f>
              <c:strCache>
                <c:ptCount val="5"/>
                <c:pt idx="0">
                  <c:v> day0 </c:v>
                </c:pt>
                <c:pt idx="1">
                  <c:v> day1</c:v>
                </c:pt>
                <c:pt idx="2">
                  <c:v> day2</c:v>
                </c:pt>
                <c:pt idx="3">
                  <c:v> day3</c:v>
                </c:pt>
                <c:pt idx="4">
                  <c:v> day4</c:v>
                </c:pt>
              </c:strCache>
            </c:strRef>
          </c:cat>
          <c:val>
            <c:numRef>
              <c:f>Sheet1!$I$12:$I$16</c:f>
              <c:numCache>
                <c:formatCode>General</c:formatCode>
                <c:ptCount val="5"/>
                <c:pt idx="0">
                  <c:v>500000</c:v>
                </c:pt>
                <c:pt idx="1">
                  <c:v>896999.9981880188</c:v>
                </c:pt>
                <c:pt idx="2">
                  <c:v>2021400.0774383547</c:v>
                </c:pt>
                <c:pt idx="3">
                  <c:v>3549500.0911712646</c:v>
                </c:pt>
                <c:pt idx="4">
                  <c:v>4237568.82681274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3B0-4B4C-8867-1A8536B94C6F}"/>
            </c:ext>
          </c:extLst>
        </c:ser>
        <c:ser>
          <c:idx val="1"/>
          <c:order val="1"/>
          <c:tx>
            <c:v>M-CHO</c:v>
          </c:tx>
          <c:val>
            <c:numRef>
              <c:f>Sheet1!$J$12:$J$16</c:f>
              <c:numCache>
                <c:formatCode>0.00</c:formatCode>
                <c:ptCount val="5"/>
                <c:pt idx="0" formatCode="General">
                  <c:v>490000</c:v>
                </c:pt>
                <c:pt idx="1">
                  <c:v>846789</c:v>
                </c:pt>
                <c:pt idx="2">
                  <c:v>2006348</c:v>
                </c:pt>
                <c:pt idx="3">
                  <c:v>3487634</c:v>
                </c:pt>
                <c:pt idx="4">
                  <c:v>396578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3B0-4B4C-8867-1A8536B94C6F}"/>
            </c:ext>
          </c:extLst>
        </c:ser>
        <c:ser>
          <c:idx val="2"/>
          <c:order val="2"/>
          <c:tx>
            <c:v>M-CHO</c:v>
          </c:tx>
          <c:val>
            <c:numRef>
              <c:f>Sheet1!$K$12:$K$16</c:f>
              <c:numCache>
                <c:formatCode>0.00</c:formatCode>
                <c:ptCount val="5"/>
                <c:pt idx="0" formatCode="General">
                  <c:v>520000</c:v>
                </c:pt>
                <c:pt idx="1">
                  <c:v>958300</c:v>
                </c:pt>
                <c:pt idx="2">
                  <c:v>2145754</c:v>
                </c:pt>
                <c:pt idx="3">
                  <c:v>3763754</c:v>
                </c:pt>
                <c:pt idx="4">
                  <c:v>39784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43B0-4B4C-8867-1A8536B94C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4512512"/>
        <c:axId val="144514048"/>
      </c:lineChart>
      <c:catAx>
        <c:axId val="14451251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44514048"/>
        <c:crosses val="autoZero"/>
        <c:auto val="1"/>
        <c:lblAlgn val="ctr"/>
        <c:lblOffset val="100"/>
        <c:noMultiLvlLbl val="0"/>
      </c:catAx>
      <c:valAx>
        <c:axId val="1445140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4451251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tr-T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834622630229778"/>
          <c:y val="0.17843501998918215"/>
          <c:w val="0.82703937007874018"/>
          <c:h val="0.68921660834062404"/>
        </c:manualLayout>
      </c:layout>
      <c:lineChart>
        <c:grouping val="standard"/>
        <c:varyColors val="0"/>
        <c:ser>
          <c:idx val="0"/>
          <c:order val="0"/>
          <c:tx>
            <c:strRef>
              <c:f>Sheet1!$B$12:$B$16</c:f>
              <c:strCache>
                <c:ptCount val="5"/>
                <c:pt idx="0">
                  <c:v> day0 </c:v>
                </c:pt>
                <c:pt idx="1">
                  <c:v> day1</c:v>
                </c:pt>
                <c:pt idx="2">
                  <c:v> day2</c:v>
                </c:pt>
                <c:pt idx="3">
                  <c:v> day3</c:v>
                </c:pt>
                <c:pt idx="4">
                  <c:v> day4</c:v>
                </c:pt>
              </c:strCache>
            </c:strRef>
          </c:tx>
          <c:cat>
            <c:strRef>
              <c:f>Sheet1!$B$12:$B$16</c:f>
              <c:strCache>
                <c:ptCount val="5"/>
                <c:pt idx="0">
                  <c:v> day0 </c:v>
                </c:pt>
                <c:pt idx="1">
                  <c:v> day1</c:v>
                </c:pt>
                <c:pt idx="2">
                  <c:v> day2</c:v>
                </c:pt>
                <c:pt idx="3">
                  <c:v> day3</c:v>
                </c:pt>
                <c:pt idx="4">
                  <c:v> day4</c:v>
                </c:pt>
              </c:strCache>
            </c:strRef>
          </c:cat>
          <c:val>
            <c:numRef>
              <c:f>Sheet1!$L$12:$L$16</c:f>
              <c:numCache>
                <c:formatCode>General</c:formatCode>
                <c:ptCount val="5"/>
                <c:pt idx="0">
                  <c:v>50000</c:v>
                </c:pt>
                <c:pt idx="1">
                  <c:v>80000</c:v>
                </c:pt>
                <c:pt idx="2">
                  <c:v>300000</c:v>
                </c:pt>
                <c:pt idx="3">
                  <c:v>1100000</c:v>
                </c:pt>
                <c:pt idx="4">
                  <c:v>123000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539-49CA-BA04-EA5B04893B11}"/>
            </c:ext>
          </c:extLst>
        </c:ser>
        <c:ser>
          <c:idx val="1"/>
          <c:order val="1"/>
          <c:tx>
            <c:strRef>
              <c:f>Sheet1!$B$12:$B$16</c:f>
              <c:strCache>
                <c:ptCount val="5"/>
                <c:pt idx="0">
                  <c:v> day0 </c:v>
                </c:pt>
                <c:pt idx="1">
                  <c:v> day1</c:v>
                </c:pt>
                <c:pt idx="2">
                  <c:v> day2</c:v>
                </c:pt>
                <c:pt idx="3">
                  <c:v> day3</c:v>
                </c:pt>
                <c:pt idx="4">
                  <c:v> day4</c:v>
                </c:pt>
              </c:strCache>
            </c:strRef>
          </c:tx>
          <c:val>
            <c:numRef>
              <c:f>Sheet1!$M$12:$M$16</c:f>
              <c:numCache>
                <c:formatCode>General</c:formatCode>
                <c:ptCount val="5"/>
                <c:pt idx="0">
                  <c:v>100000</c:v>
                </c:pt>
                <c:pt idx="1">
                  <c:v>100000</c:v>
                </c:pt>
                <c:pt idx="2">
                  <c:v>350000</c:v>
                </c:pt>
                <c:pt idx="3">
                  <c:v>1000000</c:v>
                </c:pt>
                <c:pt idx="4">
                  <c:v>112500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539-49CA-BA04-EA5B04893B11}"/>
            </c:ext>
          </c:extLst>
        </c:ser>
        <c:ser>
          <c:idx val="2"/>
          <c:order val="2"/>
          <c:tx>
            <c:strRef>
              <c:f>Sheet1!$B$12:$B$16</c:f>
              <c:strCache>
                <c:ptCount val="5"/>
                <c:pt idx="0">
                  <c:v> day0 </c:v>
                </c:pt>
                <c:pt idx="1">
                  <c:v> day1</c:v>
                </c:pt>
                <c:pt idx="2">
                  <c:v> day2</c:v>
                </c:pt>
                <c:pt idx="3">
                  <c:v> day3</c:v>
                </c:pt>
                <c:pt idx="4">
                  <c:v> day4</c:v>
                </c:pt>
              </c:strCache>
            </c:strRef>
          </c:tx>
          <c:val>
            <c:numRef>
              <c:f>Sheet1!$N$12:$N$16</c:f>
              <c:numCache>
                <c:formatCode>General</c:formatCode>
                <c:ptCount val="5"/>
                <c:pt idx="0">
                  <c:v>80000</c:v>
                </c:pt>
                <c:pt idx="1">
                  <c:v>120000</c:v>
                </c:pt>
                <c:pt idx="2">
                  <c:v>430000</c:v>
                </c:pt>
                <c:pt idx="3">
                  <c:v>1020000</c:v>
                </c:pt>
                <c:pt idx="4">
                  <c:v>115600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2539-49CA-BA04-EA5B04893B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4512512"/>
        <c:axId val="144514048"/>
      </c:lineChart>
      <c:catAx>
        <c:axId val="14451251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44514048"/>
        <c:crosses val="autoZero"/>
        <c:auto val="1"/>
        <c:lblAlgn val="ctr"/>
        <c:lblOffset val="100"/>
        <c:noMultiLvlLbl val="0"/>
      </c:catAx>
      <c:valAx>
        <c:axId val="1445140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4451251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tr-T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I$2:$I$3</c:f>
              <c:strCache>
                <c:ptCount val="2"/>
                <c:pt idx="0">
                  <c:v>SP2/0 Cell Growth Curve</c:v>
                </c:pt>
                <c:pt idx="1">
                  <c:v>(cell /ml)</c:v>
                </c:pt>
              </c:strCache>
            </c:strRef>
          </c:tx>
          <c:cat>
            <c:strRef>
              <c:f>Sheet1!$B$4:$B$8</c:f>
              <c:strCache>
                <c:ptCount val="5"/>
                <c:pt idx="0">
                  <c:v> day0 </c:v>
                </c:pt>
                <c:pt idx="1">
                  <c:v> day1</c:v>
                </c:pt>
                <c:pt idx="2">
                  <c:v> day2</c:v>
                </c:pt>
                <c:pt idx="3">
                  <c:v> day3</c:v>
                </c:pt>
                <c:pt idx="4">
                  <c:v> day4</c:v>
                </c:pt>
              </c:strCache>
            </c:strRef>
          </c:cat>
          <c:val>
            <c:numRef>
              <c:f>Sheet1!$I$4:$I$8</c:f>
              <c:numCache>
                <c:formatCode>General</c:formatCode>
                <c:ptCount val="5"/>
                <c:pt idx="0">
                  <c:v>300000</c:v>
                </c:pt>
                <c:pt idx="1">
                  <c:v>567599.99523162842</c:v>
                </c:pt>
                <c:pt idx="2">
                  <c:v>2021400.0774383547</c:v>
                </c:pt>
                <c:pt idx="3">
                  <c:v>4352899.8924255371</c:v>
                </c:pt>
                <c:pt idx="4">
                  <c:v>4474099.9771118164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0-A2AC-4C78-9257-D23CD155EE20}"/>
            </c:ext>
          </c:extLst>
        </c:ser>
        <c:ser>
          <c:idx val="1"/>
          <c:order val="1"/>
          <c:tx>
            <c:v>SP2/0</c:v>
          </c:tx>
          <c:val>
            <c:numRef>
              <c:f>Sheet1!$J$4:$J$8</c:f>
              <c:numCache>
                <c:formatCode>0.00</c:formatCode>
                <c:ptCount val="5"/>
                <c:pt idx="0" formatCode="General">
                  <c:v>275000</c:v>
                </c:pt>
                <c:pt idx="1">
                  <c:v>527845</c:v>
                </c:pt>
                <c:pt idx="2">
                  <c:v>2008250</c:v>
                </c:pt>
                <c:pt idx="3">
                  <c:v>4123800</c:v>
                </c:pt>
                <c:pt idx="4">
                  <c:v>4245302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1-A2AC-4C78-9257-D23CD155EE20}"/>
            </c:ext>
          </c:extLst>
        </c:ser>
        <c:ser>
          <c:idx val="2"/>
          <c:order val="2"/>
          <c:tx>
            <c:v>SP2/0</c:v>
          </c:tx>
          <c:val>
            <c:numRef>
              <c:f>Sheet1!$K$4:$K$8</c:f>
              <c:numCache>
                <c:formatCode>0.00</c:formatCode>
                <c:ptCount val="5"/>
                <c:pt idx="0" formatCode="General">
                  <c:v>317500</c:v>
                </c:pt>
                <c:pt idx="1">
                  <c:v>592350</c:v>
                </c:pt>
                <c:pt idx="2">
                  <c:v>2153468</c:v>
                </c:pt>
                <c:pt idx="3">
                  <c:v>4506789</c:v>
                </c:pt>
                <c:pt idx="4">
                  <c:v>4783678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2-A2AC-4C78-9257-D23CD155EE2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4626048"/>
        <c:axId val="144627584"/>
      </c:lineChart>
      <c:catAx>
        <c:axId val="1446260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44627584"/>
        <c:crosses val="autoZero"/>
        <c:auto val="1"/>
        <c:lblAlgn val="ctr"/>
        <c:lblOffset val="100"/>
        <c:noMultiLvlLbl val="0"/>
      </c:catAx>
      <c:valAx>
        <c:axId val="1446275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4462604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4324</cdr:x>
      <cdr:y>0.04155</cdr:y>
    </cdr:from>
    <cdr:to>
      <cdr:x>0.81317</cdr:x>
      <cdr:y>0.18644</cdr:y>
    </cdr:to>
    <cdr:sp macro="" textlink="">
      <cdr:nvSpPr>
        <cdr:cNvPr id="2" name="Metin kutusu 1">
          <a:extLst xmlns:a="http://schemas.openxmlformats.org/drawingml/2006/main">
            <a:ext uri="{FF2B5EF4-FFF2-40B4-BE49-F238E27FC236}">
              <a16:creationId xmlns:a16="http://schemas.microsoft.com/office/drawing/2014/main" id="{A94402C7-C2AC-48E7-87F9-B1BC9F89E438}"/>
            </a:ext>
          </a:extLst>
        </cdr:cNvPr>
        <cdr:cNvSpPr txBox="1"/>
      </cdr:nvSpPr>
      <cdr:spPr>
        <a:xfrm xmlns:a="http://schemas.openxmlformats.org/drawingml/2006/main">
          <a:off x="758825" y="80119"/>
          <a:ext cx="1778000" cy="279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100" dirty="0"/>
            <a:t>M-CHO Cells</a:t>
          </a:r>
          <a:r>
            <a:rPr lang="en-US" sz="1100" baseline="0" dirty="0"/>
            <a:t> Growth Curve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56984</cdr:x>
      <cdr:y>0.09141</cdr:y>
    </cdr:from>
    <cdr:to>
      <cdr:x>0.95859</cdr:x>
      <cdr:y>0.29895</cdr:y>
    </cdr:to>
    <cdr:grpSp>
      <cdr:nvGrpSpPr>
        <cdr:cNvPr id="6" name="Grup 5">
          <a:extLst xmlns:a="http://schemas.openxmlformats.org/drawingml/2006/main">
            <a:ext uri="{FF2B5EF4-FFF2-40B4-BE49-F238E27FC236}">
              <a16:creationId xmlns:a16="http://schemas.microsoft.com/office/drawing/2014/main" id="{A15FF3BE-ED43-40BD-9093-8A2D92F26005}"/>
            </a:ext>
          </a:extLst>
        </cdr:cNvPr>
        <cdr:cNvGrpSpPr/>
      </cdr:nvGrpSpPr>
      <cdr:grpSpPr>
        <a:xfrm xmlns:a="http://schemas.openxmlformats.org/drawingml/2006/main">
          <a:off x="1777393" y="176233"/>
          <a:ext cx="1212574" cy="400110"/>
          <a:chOff x="1777393" y="176233"/>
          <a:chExt cx="1212574" cy="400110"/>
        </a:xfrm>
      </cdr:grpSpPr>
      <cdr:sp macro="" textlink="">
        <cdr:nvSpPr>
          <cdr:cNvPr id="3" name="Metin kutusu 1">
            <a:extLst xmlns:a="http://schemas.openxmlformats.org/drawingml/2006/main">
              <a:ext uri="{FF2B5EF4-FFF2-40B4-BE49-F238E27FC236}">
                <a16:creationId xmlns:a16="http://schemas.microsoft.com/office/drawing/2014/main" id="{C1CEDC64-A09C-48E7-912F-D5923187A77F}"/>
              </a:ext>
            </a:extLst>
          </cdr:cNvPr>
          <cdr:cNvSpPr txBox="1"/>
        </cdr:nvSpPr>
        <cdr:spPr>
          <a:xfrm xmlns:a="http://schemas.openxmlformats.org/drawingml/2006/main">
            <a:off x="1777393" y="176233"/>
            <a:ext cx="1212574" cy="400110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squar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en-US" sz="1000" dirty="0"/>
              <a:t>Stationary phase sample collection</a:t>
            </a:r>
          </a:p>
        </cdr:txBody>
      </cdr:sp>
      <cdr:cxnSp macro="">
        <cdr:nvCxnSpPr>
          <cdr:cNvPr id="4" name="Düz Ok Bağlayıcısı 3">
            <a:extLst xmlns:a="http://schemas.openxmlformats.org/drawingml/2006/main">
              <a:ext uri="{FF2B5EF4-FFF2-40B4-BE49-F238E27FC236}">
                <a16:creationId xmlns:a16="http://schemas.microsoft.com/office/drawing/2014/main" id="{A4B7508C-C90C-4384-B532-61E9385642D2}"/>
              </a:ext>
            </a:extLst>
          </cdr:cNvPr>
          <cdr:cNvCxnSpPr>
            <a:cxnSpLocks xmlns:a="http://schemas.openxmlformats.org/drawingml/2006/main"/>
          </cdr:cNvCxnSpPr>
        </cdr:nvCxnSpPr>
        <cdr:spPr>
          <a:xfrm xmlns:a="http://schemas.openxmlformats.org/drawingml/2006/main">
            <a:off x="2771306" y="497699"/>
            <a:ext cx="129209" cy="78644"/>
          </a:xfrm>
          <a:prstGeom xmlns:a="http://schemas.openxmlformats.org/drawingml/2006/main" prst="straightConnector1">
            <a:avLst/>
          </a:prstGeom>
          <a:ln xmlns:a="http://schemas.openxmlformats.org/drawingml/2006/main">
            <a:tailEnd type="triangle"/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</cdr:grp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4324</cdr:x>
      <cdr:y>0.04155</cdr:y>
    </cdr:from>
    <cdr:to>
      <cdr:x>0.81317</cdr:x>
      <cdr:y>0.18644</cdr:y>
    </cdr:to>
    <cdr:sp macro="" textlink="">
      <cdr:nvSpPr>
        <cdr:cNvPr id="2" name="Metin kutusu 1">
          <a:extLst xmlns:a="http://schemas.openxmlformats.org/drawingml/2006/main">
            <a:ext uri="{FF2B5EF4-FFF2-40B4-BE49-F238E27FC236}">
              <a16:creationId xmlns:a16="http://schemas.microsoft.com/office/drawing/2014/main" id="{A94402C7-C2AC-48E7-87F9-B1BC9F89E438}"/>
            </a:ext>
          </a:extLst>
        </cdr:cNvPr>
        <cdr:cNvSpPr txBox="1"/>
      </cdr:nvSpPr>
      <cdr:spPr>
        <a:xfrm xmlns:a="http://schemas.openxmlformats.org/drawingml/2006/main">
          <a:off x="758825" y="80119"/>
          <a:ext cx="1778000" cy="279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100"/>
            <a:t>CHO-K1 Cells</a:t>
          </a:r>
          <a:r>
            <a:rPr lang="en-US" sz="1100" baseline="0"/>
            <a:t> Growth Curve</a:t>
          </a:r>
          <a:endParaRPr lang="en-US" sz="110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26361</cdr:x>
      <cdr:y>0</cdr:y>
    </cdr:from>
    <cdr:to>
      <cdr:x>0.82745</cdr:x>
      <cdr:y>0.14639</cdr:y>
    </cdr:to>
    <cdr:sp macro="" textlink="">
      <cdr:nvSpPr>
        <cdr:cNvPr id="2" name="Metin kutusu 1"/>
        <cdr:cNvSpPr txBox="1"/>
      </cdr:nvSpPr>
      <cdr:spPr>
        <a:xfrm xmlns:a="http://schemas.openxmlformats.org/drawingml/2006/main">
          <a:off x="831109" y="-3932237"/>
          <a:ext cx="1777660" cy="27933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/>
            <a:t>SP2/0 Cells</a:t>
          </a:r>
          <a:r>
            <a:rPr lang="en-US" sz="1100" baseline="0" dirty="0"/>
            <a:t> Growth Curve</a:t>
          </a:r>
          <a:endParaRPr lang="en-US" sz="11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Başlık Slayd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CC7C8D5A-1A5E-4852-BAAD-05C00362F8E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Alt Başlık 2">
            <a:extLst>
              <a:ext uri="{FF2B5EF4-FFF2-40B4-BE49-F238E27FC236}">
                <a16:creationId xmlns:a16="http://schemas.microsoft.com/office/drawing/2014/main" id="{FCB8708B-4ACF-4E07-B819-D30E65C579C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r-TR"/>
              <a:t>Asıl alt başlık stilini düzenlemek için tıklayın</a:t>
            </a:r>
            <a:endParaRPr lang="en-US"/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CFF92B73-777F-4309-B2F9-8BA86D2997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E02C00-D1FC-431F-8FA2-45F640488D67}" type="datetimeFigureOut">
              <a:rPr lang="en-US" smtClean="0"/>
              <a:t>11/22/2021</a:t>
            </a:fld>
            <a:endParaRPr lang="en-US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FDF6C084-2DB7-43AD-96B6-F77E00DD6B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9E8CF502-B975-4FEE-8B2B-965AF16BCF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81FE4-E877-4EF7-9074-0819F6CE1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83809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Başlık ve Dikey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FF78FA35-236C-482A-8231-AF8C9C85D6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Dikey Metin Yer Tutucusu 2">
            <a:extLst>
              <a:ext uri="{FF2B5EF4-FFF2-40B4-BE49-F238E27FC236}">
                <a16:creationId xmlns:a16="http://schemas.microsoft.com/office/drawing/2014/main" id="{FFBFCA54-A607-439D-98BD-716DABF596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E0BD3240-24C3-4B5D-B049-A6D3D2E08D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E02C00-D1FC-431F-8FA2-45F640488D67}" type="datetimeFigureOut">
              <a:rPr lang="en-US" smtClean="0"/>
              <a:t>11/22/2021</a:t>
            </a:fld>
            <a:endParaRPr lang="en-US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16C4B203-405C-4904-9F88-6FF2575C7F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50557642-AE96-4015-9D09-37BCAAC179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81FE4-E877-4EF7-9074-0819F6CE1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487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Dikey Başlık ve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key Başlık 1">
            <a:extLst>
              <a:ext uri="{FF2B5EF4-FFF2-40B4-BE49-F238E27FC236}">
                <a16:creationId xmlns:a16="http://schemas.microsoft.com/office/drawing/2014/main" id="{897505BF-9A90-4888-AE34-DA600093143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Dikey Metin Yer Tutucusu 2">
            <a:extLst>
              <a:ext uri="{FF2B5EF4-FFF2-40B4-BE49-F238E27FC236}">
                <a16:creationId xmlns:a16="http://schemas.microsoft.com/office/drawing/2014/main" id="{A889397C-C541-4E54-995C-FB8BAFEBD9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6B7C2E17-A772-4A82-9C14-5C60352DE8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E02C00-D1FC-431F-8FA2-45F640488D67}" type="datetimeFigureOut">
              <a:rPr lang="en-US" smtClean="0"/>
              <a:t>11/22/2021</a:t>
            </a:fld>
            <a:endParaRPr lang="en-US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1C44104F-7E59-4360-9E2E-4B560E5D7B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D2586D9E-9EE6-46F4-8777-FB7D44EF3C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81FE4-E877-4EF7-9074-0819F6CE1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247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aşlık ve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76661267-D413-43FA-8CEB-1A4BF44249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84EB256E-9C70-4272-8654-D71EEAED31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98CB3C74-E614-4EEE-B987-10E89B0519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E02C00-D1FC-431F-8FA2-45F640488D67}" type="datetimeFigureOut">
              <a:rPr lang="en-US" smtClean="0"/>
              <a:t>11/22/2021</a:t>
            </a:fld>
            <a:endParaRPr lang="en-US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16171AC0-642A-4D63-84DD-6FD1126280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C388698D-C379-4BDC-93F8-9F27DD51EA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81FE4-E877-4EF7-9074-0819F6CE1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3564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Bölüm Üst Bilgis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D6742586-6D84-4E5A-83F7-DA4BFAF7EE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B3393291-9425-4C5E-AC95-AC2F600096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5FBA1F84-DCEE-4D18-8341-C9AA113710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E02C00-D1FC-431F-8FA2-45F640488D67}" type="datetimeFigureOut">
              <a:rPr lang="en-US" smtClean="0"/>
              <a:t>11/22/2021</a:t>
            </a:fld>
            <a:endParaRPr lang="en-US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513C3FD2-0A3A-4BD8-914C-9FDD83FF1D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DD5C1119-36C8-4427-B36B-52DAC0FEAF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81FE4-E877-4EF7-9074-0819F6CE1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3624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İki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89E046E0-6191-4FA4-AEFB-6683EC02F9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49407CA5-0843-4675-8637-4E598CA9B3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4" name="İçerik Yer Tutucusu 3">
            <a:extLst>
              <a:ext uri="{FF2B5EF4-FFF2-40B4-BE49-F238E27FC236}">
                <a16:creationId xmlns:a16="http://schemas.microsoft.com/office/drawing/2014/main" id="{43D2B641-8F80-4AF4-8F5D-03745AE60A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75C95904-B001-4F6F-88A8-D94750C660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E02C00-D1FC-431F-8FA2-45F640488D67}" type="datetimeFigureOut">
              <a:rPr lang="en-US" smtClean="0"/>
              <a:t>11/22/2021</a:t>
            </a:fld>
            <a:endParaRPr lang="en-US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FFCAF74D-806A-4E8F-83E5-C0E7663C00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9242FDFC-7BAB-4ABA-903A-E7B9FAFEAF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81FE4-E877-4EF7-9074-0819F6CE1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53729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Karşılaştırm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97104E23-64AF-4152-929C-E6DA78B69F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8FFDB23D-3C64-4ADF-ADF9-40149C0008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İçerik Yer Tutucusu 3">
            <a:extLst>
              <a:ext uri="{FF2B5EF4-FFF2-40B4-BE49-F238E27FC236}">
                <a16:creationId xmlns:a16="http://schemas.microsoft.com/office/drawing/2014/main" id="{13B8EEE8-9199-4E1F-A929-31EA083B57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5" name="Metin Yer Tutucusu 4">
            <a:extLst>
              <a:ext uri="{FF2B5EF4-FFF2-40B4-BE49-F238E27FC236}">
                <a16:creationId xmlns:a16="http://schemas.microsoft.com/office/drawing/2014/main" id="{1269C9A7-87C3-4D12-A61A-990E60A0CC2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6" name="İçerik Yer Tutucusu 5">
            <a:extLst>
              <a:ext uri="{FF2B5EF4-FFF2-40B4-BE49-F238E27FC236}">
                <a16:creationId xmlns:a16="http://schemas.microsoft.com/office/drawing/2014/main" id="{2ECF4552-D17B-45F6-8748-98D90D18315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7" name="Veri Yer Tutucusu 6">
            <a:extLst>
              <a:ext uri="{FF2B5EF4-FFF2-40B4-BE49-F238E27FC236}">
                <a16:creationId xmlns:a16="http://schemas.microsoft.com/office/drawing/2014/main" id="{0E200148-4CC7-47C6-9B6B-0BA4EDFD41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E02C00-D1FC-431F-8FA2-45F640488D67}" type="datetimeFigureOut">
              <a:rPr lang="en-US" smtClean="0"/>
              <a:t>11/22/2021</a:t>
            </a:fld>
            <a:endParaRPr lang="en-US"/>
          </a:p>
        </p:txBody>
      </p:sp>
      <p:sp>
        <p:nvSpPr>
          <p:cNvPr id="8" name="Alt Bilgi Yer Tutucusu 7">
            <a:extLst>
              <a:ext uri="{FF2B5EF4-FFF2-40B4-BE49-F238E27FC236}">
                <a16:creationId xmlns:a16="http://schemas.microsoft.com/office/drawing/2014/main" id="{18C51EF3-20D2-4FB7-8F8C-03A7DF64FE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ayt Numarası Yer Tutucusu 8">
            <a:extLst>
              <a:ext uri="{FF2B5EF4-FFF2-40B4-BE49-F238E27FC236}">
                <a16:creationId xmlns:a16="http://schemas.microsoft.com/office/drawing/2014/main" id="{A7939D28-574A-4083-A7CC-5E1299E80E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81FE4-E877-4EF7-9074-0819F6CE1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41079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Yalnızca Başlı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0BC29392-0238-4287-B3B7-14971B2832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Veri Yer Tutucusu 2">
            <a:extLst>
              <a:ext uri="{FF2B5EF4-FFF2-40B4-BE49-F238E27FC236}">
                <a16:creationId xmlns:a16="http://schemas.microsoft.com/office/drawing/2014/main" id="{5D749B44-1C44-4E32-BDF5-B8626C97D0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E02C00-D1FC-431F-8FA2-45F640488D67}" type="datetimeFigureOut">
              <a:rPr lang="en-US" smtClean="0"/>
              <a:t>11/22/2021</a:t>
            </a:fld>
            <a:endParaRPr lang="en-US"/>
          </a:p>
        </p:txBody>
      </p:sp>
      <p:sp>
        <p:nvSpPr>
          <p:cNvPr id="4" name="Alt Bilgi Yer Tutucusu 3">
            <a:extLst>
              <a:ext uri="{FF2B5EF4-FFF2-40B4-BE49-F238E27FC236}">
                <a16:creationId xmlns:a16="http://schemas.microsoft.com/office/drawing/2014/main" id="{EF75BC74-2161-4BA7-AE4D-A0051453B8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ayt Numarası Yer Tutucusu 4">
            <a:extLst>
              <a:ext uri="{FF2B5EF4-FFF2-40B4-BE49-F238E27FC236}">
                <a16:creationId xmlns:a16="http://schemas.microsoft.com/office/drawing/2014/main" id="{94783807-24EC-4E41-AAC9-EB2D3519EB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81FE4-E877-4EF7-9074-0819F6CE1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38557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o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i Yer Tutucusu 1">
            <a:extLst>
              <a:ext uri="{FF2B5EF4-FFF2-40B4-BE49-F238E27FC236}">
                <a16:creationId xmlns:a16="http://schemas.microsoft.com/office/drawing/2014/main" id="{F2D477A4-E630-45EA-8802-4C86EF2D46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E02C00-D1FC-431F-8FA2-45F640488D67}" type="datetimeFigureOut">
              <a:rPr lang="en-US" smtClean="0"/>
              <a:t>11/22/2021</a:t>
            </a:fld>
            <a:endParaRPr lang="en-US"/>
          </a:p>
        </p:txBody>
      </p:sp>
      <p:sp>
        <p:nvSpPr>
          <p:cNvPr id="3" name="Alt Bilgi Yer Tutucusu 2">
            <a:extLst>
              <a:ext uri="{FF2B5EF4-FFF2-40B4-BE49-F238E27FC236}">
                <a16:creationId xmlns:a16="http://schemas.microsoft.com/office/drawing/2014/main" id="{9CCE3518-8188-41A7-88DE-E1039D90A2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ayt Numarası Yer Tutucusu 3">
            <a:extLst>
              <a:ext uri="{FF2B5EF4-FFF2-40B4-BE49-F238E27FC236}">
                <a16:creationId xmlns:a16="http://schemas.microsoft.com/office/drawing/2014/main" id="{DCC77E92-AD29-4745-8FCF-2F1576DFE4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81FE4-E877-4EF7-9074-0819F6CE1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53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Başlıklı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D3E213BB-702A-41D4-AA01-A15924367F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67F28BC0-97E0-409A-9295-445393012F2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4" name="Metin Yer Tutucusu 3">
            <a:extLst>
              <a:ext uri="{FF2B5EF4-FFF2-40B4-BE49-F238E27FC236}">
                <a16:creationId xmlns:a16="http://schemas.microsoft.com/office/drawing/2014/main" id="{639176E9-3962-4303-AE8E-324F8BC6D8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05A2B78C-033A-4FC0-9433-3E07DFA763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E02C00-D1FC-431F-8FA2-45F640488D67}" type="datetimeFigureOut">
              <a:rPr lang="en-US" smtClean="0"/>
              <a:t>11/22/2021</a:t>
            </a:fld>
            <a:endParaRPr lang="en-US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C364DC11-D2C2-4139-B89A-5202D83901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D6059925-7792-40F0-B334-DF73D9A308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81FE4-E877-4EF7-9074-0819F6CE1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70452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aşlıklı Resi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AAAD04EE-444F-4E23-922E-60408C0332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Resim Yer Tutucusu 2">
            <a:extLst>
              <a:ext uri="{FF2B5EF4-FFF2-40B4-BE49-F238E27FC236}">
                <a16:creationId xmlns:a16="http://schemas.microsoft.com/office/drawing/2014/main" id="{B30E1A80-E286-420E-9A6D-8FE43C171BD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etin Yer Tutucusu 3">
            <a:extLst>
              <a:ext uri="{FF2B5EF4-FFF2-40B4-BE49-F238E27FC236}">
                <a16:creationId xmlns:a16="http://schemas.microsoft.com/office/drawing/2014/main" id="{140F75F7-D365-4B2A-A6A0-1469FFB487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5EC20331-9C4E-44B9-B530-06A8B7A1A5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E02C00-D1FC-431F-8FA2-45F640488D67}" type="datetimeFigureOut">
              <a:rPr lang="en-US" smtClean="0"/>
              <a:t>11/22/2021</a:t>
            </a:fld>
            <a:endParaRPr lang="en-US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C4E89E9C-5A73-44FA-8E11-D4CE88390B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8C277129-5EAD-4783-87EF-721B44FAA7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81FE4-E877-4EF7-9074-0819F6CE1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919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Yer Tutucusu 1">
            <a:extLst>
              <a:ext uri="{FF2B5EF4-FFF2-40B4-BE49-F238E27FC236}">
                <a16:creationId xmlns:a16="http://schemas.microsoft.com/office/drawing/2014/main" id="{8EA90FBC-B59E-4552-B1B3-1705F82918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FF9E0AA1-0462-41FE-B018-75CCA97615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8A9C722A-9A57-4134-838B-61E57353F3F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E02C00-D1FC-431F-8FA2-45F640488D67}" type="datetimeFigureOut">
              <a:rPr lang="en-US" smtClean="0"/>
              <a:t>11/22/2021</a:t>
            </a:fld>
            <a:endParaRPr lang="en-US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A556615C-93A8-4FE7-A9B5-E115677F6A5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10DAC67B-2267-45F1-90A7-735F334D714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981FE4-E877-4EF7-9074-0819F6CE1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0294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8307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214"/>
          <a:stretch/>
        </p:blipFill>
        <p:spPr>
          <a:xfrm>
            <a:off x="243418" y="1189464"/>
            <a:ext cx="5600700" cy="3708744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8308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465"/>
          <a:stretch/>
        </p:blipFill>
        <p:spPr bwMode="auto">
          <a:xfrm>
            <a:off x="6098891" y="1189463"/>
            <a:ext cx="5285317" cy="35547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535259" y="5218771"/>
            <a:ext cx="972386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Supplementary Figure S1a. Transcriptomics comparison of exponential and stationary phases of M-CHO and SP2/0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85386" y="1338148"/>
            <a:ext cx="41482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M-CHO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864196" y="1334776"/>
            <a:ext cx="41482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SP2/0</a:t>
            </a:r>
          </a:p>
        </p:txBody>
      </p:sp>
    </p:spTree>
    <p:extLst>
      <p:ext uri="{BB962C8B-B14F-4D97-AF65-F5344CB8AC3E}">
        <p14:creationId xmlns:p14="http://schemas.microsoft.com/office/powerpoint/2010/main" val="42741961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9331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48" b="1"/>
          <a:stretch/>
        </p:blipFill>
        <p:spPr>
          <a:xfrm>
            <a:off x="162986" y="1442223"/>
            <a:ext cx="5884333" cy="3333364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9332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02"/>
          <a:stretch/>
        </p:blipFill>
        <p:spPr bwMode="auto">
          <a:xfrm>
            <a:off x="6047318" y="1442223"/>
            <a:ext cx="5880100" cy="33333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535259" y="5218771"/>
            <a:ext cx="972386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Supplementary Figure S1b. Comparison of exponential and stationary proteomics data for M-CHO and SP2/0 cell lines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906967" y="1584369"/>
            <a:ext cx="41482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M-CHO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849328" y="1617274"/>
            <a:ext cx="41482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SP2/0</a:t>
            </a:r>
          </a:p>
        </p:txBody>
      </p:sp>
    </p:spTree>
    <p:extLst>
      <p:ext uri="{BB962C8B-B14F-4D97-AF65-F5344CB8AC3E}">
        <p14:creationId xmlns:p14="http://schemas.microsoft.com/office/powerpoint/2010/main" val="39204974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İçerik Yer Tutucusu 3">
            <a:extLst>
              <a:ext uri="{FF2B5EF4-FFF2-40B4-BE49-F238E27FC236}">
                <a16:creationId xmlns:a16="http://schemas.microsoft.com/office/drawing/2014/main" id="{7A31677A-3EBB-466B-B2A8-E98FB866B436}"/>
              </a:ext>
            </a:extLst>
          </p:cNvPr>
          <p:cNvPicPr>
            <a:picLocks noGrp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1349" y="799465"/>
            <a:ext cx="5463451" cy="3914775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Metin kutusu 4">
            <a:extLst>
              <a:ext uri="{FF2B5EF4-FFF2-40B4-BE49-F238E27FC236}">
                <a16:creationId xmlns:a16="http://schemas.microsoft.com/office/drawing/2014/main" id="{140F1A2C-E76B-4DE0-A462-B87EADFC1F16}"/>
              </a:ext>
            </a:extLst>
          </p:cNvPr>
          <p:cNvSpPr txBox="1"/>
          <p:nvPr/>
        </p:nvSpPr>
        <p:spPr>
          <a:xfrm>
            <a:off x="1191349" y="5313680"/>
            <a:ext cx="928361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Supplemantary</a:t>
            </a:r>
            <a:r>
              <a:rPr lang="en-US" dirty="0"/>
              <a:t> Figure S2 . Box plot figure for justification of the same amount of protein injected to LC/MS/MS</a:t>
            </a:r>
          </a:p>
        </p:txBody>
      </p:sp>
    </p:spTree>
    <p:extLst>
      <p:ext uri="{BB962C8B-B14F-4D97-AF65-F5344CB8AC3E}">
        <p14:creationId xmlns:p14="http://schemas.microsoft.com/office/powerpoint/2010/main" val="629942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Metin kutusu 7">
            <a:extLst>
              <a:ext uri="{FF2B5EF4-FFF2-40B4-BE49-F238E27FC236}">
                <a16:creationId xmlns:a16="http://schemas.microsoft.com/office/drawing/2014/main" id="{B622CC69-6477-475B-9660-F150B1815D96}"/>
              </a:ext>
            </a:extLst>
          </p:cNvPr>
          <p:cNvSpPr txBox="1"/>
          <p:nvPr/>
        </p:nvSpPr>
        <p:spPr>
          <a:xfrm>
            <a:off x="1235710" y="2853809"/>
            <a:ext cx="6096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Supplementary Figure S3a. Growth curve of M-CHO cells</a:t>
            </a:r>
          </a:p>
        </p:txBody>
      </p:sp>
      <p:sp>
        <p:nvSpPr>
          <p:cNvPr id="9" name="Metin kutusu 8">
            <a:extLst>
              <a:ext uri="{FF2B5EF4-FFF2-40B4-BE49-F238E27FC236}">
                <a16:creationId xmlns:a16="http://schemas.microsoft.com/office/drawing/2014/main" id="{562BBEC2-3423-4EA6-A0A6-F3943E65DA9D}"/>
              </a:ext>
            </a:extLst>
          </p:cNvPr>
          <p:cNvSpPr txBox="1"/>
          <p:nvPr/>
        </p:nvSpPr>
        <p:spPr>
          <a:xfrm>
            <a:off x="4855210" y="2845742"/>
            <a:ext cx="6096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Supplementary Figure S3b. Growth curve of CHO-K1 cells</a:t>
            </a:r>
          </a:p>
        </p:txBody>
      </p:sp>
      <p:sp>
        <p:nvSpPr>
          <p:cNvPr id="10" name="TextBox 6">
            <a:extLst>
              <a:ext uri="{FF2B5EF4-FFF2-40B4-BE49-F238E27FC236}">
                <a16:creationId xmlns:a16="http://schemas.microsoft.com/office/drawing/2014/main" id="{58D1842C-DD0B-48BF-A2E5-7A3F7462A35C}"/>
              </a:ext>
            </a:extLst>
          </p:cNvPr>
          <p:cNvSpPr txBox="1"/>
          <p:nvPr/>
        </p:nvSpPr>
        <p:spPr>
          <a:xfrm>
            <a:off x="1169035" y="5959088"/>
            <a:ext cx="48307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Figure S4. Growth curve of SP2/0 cells</a:t>
            </a:r>
          </a:p>
        </p:txBody>
      </p:sp>
      <p:grpSp>
        <p:nvGrpSpPr>
          <p:cNvPr id="27" name="Grup 26">
            <a:extLst>
              <a:ext uri="{FF2B5EF4-FFF2-40B4-BE49-F238E27FC236}">
                <a16:creationId xmlns:a16="http://schemas.microsoft.com/office/drawing/2014/main" id="{81B52720-BFC5-489F-81B9-9540F9A5F1CD}"/>
              </a:ext>
            </a:extLst>
          </p:cNvPr>
          <p:cNvGrpSpPr/>
          <p:nvPr/>
        </p:nvGrpSpPr>
        <p:grpSpPr>
          <a:xfrm>
            <a:off x="1126490" y="807273"/>
            <a:ext cx="3119120" cy="1927860"/>
            <a:chOff x="1126490" y="807273"/>
            <a:chExt cx="3119120" cy="1927860"/>
          </a:xfrm>
        </p:grpSpPr>
        <p:graphicFrame>
          <p:nvGraphicFramePr>
            <p:cNvPr id="5" name="Grafik 4">
              <a:extLst>
                <a:ext uri="{FF2B5EF4-FFF2-40B4-BE49-F238E27FC236}">
                  <a16:creationId xmlns:a16="http://schemas.microsoft.com/office/drawing/2014/main" id="{00000000-0008-0000-0000-00000A000000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3548215526"/>
                </p:ext>
              </p:extLst>
            </p:nvPr>
          </p:nvGraphicFramePr>
          <p:xfrm>
            <a:off x="1126490" y="807273"/>
            <a:ext cx="3119120" cy="19278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13" name="Grup 12">
              <a:extLst>
                <a:ext uri="{FF2B5EF4-FFF2-40B4-BE49-F238E27FC236}">
                  <a16:creationId xmlns:a16="http://schemas.microsoft.com/office/drawing/2014/main" id="{C77614C1-67B1-4B7A-955D-62F574517499}"/>
                </a:ext>
              </a:extLst>
            </p:cNvPr>
            <p:cNvGrpSpPr/>
            <p:nvPr/>
          </p:nvGrpSpPr>
          <p:grpSpPr>
            <a:xfrm>
              <a:off x="1818861" y="1609736"/>
              <a:ext cx="1212574" cy="400110"/>
              <a:chOff x="1818861" y="1609736"/>
              <a:chExt cx="1212574" cy="400110"/>
            </a:xfrm>
          </p:grpSpPr>
          <p:sp>
            <p:nvSpPr>
              <p:cNvPr id="2" name="Metin kutusu 1">
                <a:extLst>
                  <a:ext uri="{FF2B5EF4-FFF2-40B4-BE49-F238E27FC236}">
                    <a16:creationId xmlns:a16="http://schemas.microsoft.com/office/drawing/2014/main" id="{C1CEDC64-A09C-48E7-912F-D5923187A77F}"/>
                  </a:ext>
                </a:extLst>
              </p:cNvPr>
              <p:cNvSpPr txBox="1"/>
              <p:nvPr/>
            </p:nvSpPr>
            <p:spPr>
              <a:xfrm>
                <a:off x="1818861" y="1609736"/>
                <a:ext cx="1212574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Exponential phase sample collection</a:t>
                </a:r>
              </a:p>
            </p:txBody>
          </p:sp>
          <p:cxnSp>
            <p:nvCxnSpPr>
              <p:cNvPr id="7" name="Düz Ok Bağlayıcısı 6">
                <a:extLst>
                  <a:ext uri="{FF2B5EF4-FFF2-40B4-BE49-F238E27FC236}">
                    <a16:creationId xmlns:a16="http://schemas.microsoft.com/office/drawing/2014/main" id="{A4B7508C-C90C-4384-B532-61E9385642D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12774" y="1809791"/>
                <a:ext cx="129209" cy="78644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6" name="Grup 25">
            <a:extLst>
              <a:ext uri="{FF2B5EF4-FFF2-40B4-BE49-F238E27FC236}">
                <a16:creationId xmlns:a16="http://schemas.microsoft.com/office/drawing/2014/main" id="{F7508C32-4787-41DA-9757-6760B9FA7589}"/>
              </a:ext>
            </a:extLst>
          </p:cNvPr>
          <p:cNvGrpSpPr/>
          <p:nvPr/>
        </p:nvGrpSpPr>
        <p:grpSpPr>
          <a:xfrm>
            <a:off x="4622165" y="740727"/>
            <a:ext cx="3119120" cy="1927860"/>
            <a:chOff x="4622165" y="740727"/>
            <a:chExt cx="3119120" cy="1927860"/>
          </a:xfrm>
        </p:grpSpPr>
        <p:graphicFrame>
          <p:nvGraphicFramePr>
            <p:cNvPr id="6" name="Grafik 5">
              <a:extLst>
                <a:ext uri="{FF2B5EF4-FFF2-40B4-BE49-F238E27FC236}">
                  <a16:creationId xmlns:a16="http://schemas.microsoft.com/office/drawing/2014/main" id="{646CF57F-7195-47CF-B246-65D4E420F14C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573996934"/>
                </p:ext>
              </p:extLst>
            </p:nvPr>
          </p:nvGraphicFramePr>
          <p:xfrm>
            <a:off x="4622165" y="740727"/>
            <a:ext cx="3119120" cy="19278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4" name="Metin kutusu 13">
              <a:extLst>
                <a:ext uri="{FF2B5EF4-FFF2-40B4-BE49-F238E27FC236}">
                  <a16:creationId xmlns:a16="http://schemas.microsoft.com/office/drawing/2014/main" id="{B8C15166-7579-472F-BABF-422DD75502A1}"/>
                </a:ext>
              </a:extLst>
            </p:cNvPr>
            <p:cNvSpPr txBox="1"/>
            <p:nvPr/>
          </p:nvSpPr>
          <p:spPr>
            <a:xfrm>
              <a:off x="5229584" y="1688380"/>
              <a:ext cx="121257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Exponential phase sample collection</a:t>
              </a:r>
            </a:p>
          </p:txBody>
        </p:sp>
        <p:sp>
          <p:nvSpPr>
            <p:cNvPr id="16" name="Metin kutusu 1">
              <a:extLst>
                <a:ext uri="{FF2B5EF4-FFF2-40B4-BE49-F238E27FC236}">
                  <a16:creationId xmlns:a16="http://schemas.microsoft.com/office/drawing/2014/main" id="{6EFF283F-2EE7-4F59-89AC-360166FEC1FA}"/>
                </a:ext>
              </a:extLst>
            </p:cNvPr>
            <p:cNvSpPr txBox="1"/>
            <p:nvPr/>
          </p:nvSpPr>
          <p:spPr>
            <a:xfrm>
              <a:off x="6344478" y="994992"/>
              <a:ext cx="121257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/>
                <a:t>Stationary phase sample collection</a:t>
              </a:r>
            </a:p>
          </p:txBody>
        </p:sp>
        <p:cxnSp>
          <p:nvCxnSpPr>
            <p:cNvPr id="18" name="Düz Ok Bağlayıcısı 17">
              <a:extLst>
                <a:ext uri="{FF2B5EF4-FFF2-40B4-BE49-F238E27FC236}">
                  <a16:creationId xmlns:a16="http://schemas.microsoft.com/office/drawing/2014/main" id="{C31938C1-9390-4535-8297-D63D9B849C6E}"/>
                </a:ext>
              </a:extLst>
            </p:cNvPr>
            <p:cNvCxnSpPr>
              <a:cxnSpLocks/>
            </p:cNvCxnSpPr>
            <p:nvPr/>
          </p:nvCxnSpPr>
          <p:spPr>
            <a:xfrm>
              <a:off x="6279873" y="1888435"/>
              <a:ext cx="129209" cy="7864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Düz Ok Bağlayıcısı 18">
              <a:extLst>
                <a:ext uri="{FF2B5EF4-FFF2-40B4-BE49-F238E27FC236}">
                  <a16:creationId xmlns:a16="http://schemas.microsoft.com/office/drawing/2014/main" id="{C31938C1-9390-4535-8297-D63D9B849C6E}"/>
                </a:ext>
              </a:extLst>
            </p:cNvPr>
            <p:cNvCxnSpPr>
              <a:cxnSpLocks/>
            </p:cNvCxnSpPr>
            <p:nvPr/>
          </p:nvCxnSpPr>
          <p:spPr>
            <a:xfrm>
              <a:off x="7331710" y="1155725"/>
              <a:ext cx="129209" cy="7864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" name="Grup 23">
            <a:extLst>
              <a:ext uri="{FF2B5EF4-FFF2-40B4-BE49-F238E27FC236}">
                <a16:creationId xmlns:a16="http://schemas.microsoft.com/office/drawing/2014/main" id="{76C41404-E434-425E-8A04-BE000A62C3C7}"/>
              </a:ext>
            </a:extLst>
          </p:cNvPr>
          <p:cNvGrpSpPr/>
          <p:nvPr/>
        </p:nvGrpSpPr>
        <p:grpSpPr>
          <a:xfrm>
            <a:off x="1092835" y="3932237"/>
            <a:ext cx="3152775" cy="1908175"/>
            <a:chOff x="1092835" y="3932237"/>
            <a:chExt cx="3152775" cy="1908175"/>
          </a:xfrm>
        </p:grpSpPr>
        <p:graphicFrame>
          <p:nvGraphicFramePr>
            <p:cNvPr id="4" name="Grafik 3">
              <a:extLst>
                <a:ext uri="{FF2B5EF4-FFF2-40B4-BE49-F238E27FC236}">
                  <a16:creationId xmlns:a16="http://schemas.microsoft.com/office/drawing/2014/main" id="{00000000-0008-0000-0000-000009000000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992497355"/>
                </p:ext>
              </p:extLst>
            </p:nvPr>
          </p:nvGraphicFramePr>
          <p:xfrm>
            <a:off x="1092835" y="3932237"/>
            <a:ext cx="3152775" cy="190817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5" name="Metin kutusu 14">
              <a:extLst>
                <a:ext uri="{FF2B5EF4-FFF2-40B4-BE49-F238E27FC236}">
                  <a16:creationId xmlns:a16="http://schemas.microsoft.com/office/drawing/2014/main" id="{62301027-DB82-4801-9E93-694629C85643}"/>
                </a:ext>
              </a:extLst>
            </p:cNvPr>
            <p:cNvSpPr txBox="1"/>
            <p:nvPr/>
          </p:nvSpPr>
          <p:spPr>
            <a:xfrm>
              <a:off x="1818861" y="4727089"/>
              <a:ext cx="121257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Exponential phase sample collection</a:t>
              </a:r>
            </a:p>
          </p:txBody>
        </p:sp>
        <p:sp>
          <p:nvSpPr>
            <p:cNvPr id="17" name="Metin kutusu 1">
              <a:extLst>
                <a:ext uri="{FF2B5EF4-FFF2-40B4-BE49-F238E27FC236}">
                  <a16:creationId xmlns:a16="http://schemas.microsoft.com/office/drawing/2014/main" id="{FDB9341F-ED69-4024-99DF-D6DDA0E38B33}"/>
                </a:ext>
              </a:extLst>
            </p:cNvPr>
            <p:cNvSpPr txBox="1"/>
            <p:nvPr/>
          </p:nvSpPr>
          <p:spPr>
            <a:xfrm>
              <a:off x="2812774" y="4038781"/>
              <a:ext cx="121257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/>
                <a:t>Stationary phase sample collection</a:t>
              </a:r>
            </a:p>
          </p:txBody>
        </p:sp>
        <p:cxnSp>
          <p:nvCxnSpPr>
            <p:cNvPr id="22" name="Düz Ok Bağlayıcısı 21">
              <a:extLst>
                <a:ext uri="{FF2B5EF4-FFF2-40B4-BE49-F238E27FC236}">
                  <a16:creationId xmlns:a16="http://schemas.microsoft.com/office/drawing/2014/main" id="{B7F4BB17-11C8-4745-9F35-976EF9262875}"/>
                </a:ext>
              </a:extLst>
            </p:cNvPr>
            <p:cNvCxnSpPr>
              <a:cxnSpLocks/>
            </p:cNvCxnSpPr>
            <p:nvPr/>
          </p:nvCxnSpPr>
          <p:spPr>
            <a:xfrm>
              <a:off x="2774678" y="4923178"/>
              <a:ext cx="129209" cy="7864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Düz Ok Bağlayıcısı 22">
              <a:extLst>
                <a:ext uri="{FF2B5EF4-FFF2-40B4-BE49-F238E27FC236}">
                  <a16:creationId xmlns:a16="http://schemas.microsoft.com/office/drawing/2014/main" id="{EF74FC5F-235A-413E-9FF9-69FA04A2A709}"/>
                </a:ext>
              </a:extLst>
            </p:cNvPr>
            <p:cNvCxnSpPr>
              <a:cxnSpLocks/>
            </p:cNvCxnSpPr>
            <p:nvPr/>
          </p:nvCxnSpPr>
          <p:spPr>
            <a:xfrm>
              <a:off x="3702330" y="4220813"/>
              <a:ext cx="129209" cy="7864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2548093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up 9">
            <a:extLst>
              <a:ext uri="{FF2B5EF4-FFF2-40B4-BE49-F238E27FC236}">
                <a16:creationId xmlns:a16="http://schemas.microsoft.com/office/drawing/2014/main" id="{402BE29C-0D26-463F-A4BD-532852AF736D}"/>
              </a:ext>
            </a:extLst>
          </p:cNvPr>
          <p:cNvGrpSpPr/>
          <p:nvPr/>
        </p:nvGrpSpPr>
        <p:grpSpPr>
          <a:xfrm>
            <a:off x="1" y="380303"/>
            <a:ext cx="6308519" cy="3405232"/>
            <a:chOff x="1102519" y="1201341"/>
            <a:chExt cx="3469481" cy="1713310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999" t="28268" r="13834" b="17867"/>
            <a:stretch>
              <a:fillRect/>
            </a:stretch>
          </p:blipFill>
          <p:spPr bwMode="auto">
            <a:xfrm>
              <a:off x="1102519" y="1201341"/>
              <a:ext cx="3469481" cy="17133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Oval 4"/>
            <p:cNvSpPr/>
            <p:nvPr/>
          </p:nvSpPr>
          <p:spPr>
            <a:xfrm>
              <a:off x="2571750" y="1714500"/>
              <a:ext cx="706041" cy="205978"/>
            </a:xfrm>
            <a:prstGeom prst="ellipse">
              <a:avLst/>
            </a:prstGeom>
            <a:noFill/>
            <a:ln w="60325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</p:grpSp>
      <p:sp>
        <p:nvSpPr>
          <p:cNvPr id="7" name="TextBox 6"/>
          <p:cNvSpPr txBox="1"/>
          <p:nvPr/>
        </p:nvSpPr>
        <p:spPr>
          <a:xfrm>
            <a:off x="522288" y="3851339"/>
            <a:ext cx="51054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5. Actin cytoskeleton </a:t>
            </a:r>
            <a:r>
              <a:rPr lang="en-US" dirty="0" err="1"/>
              <a:t>signalling</a:t>
            </a:r>
            <a:r>
              <a:rPr lang="en-US" dirty="0"/>
              <a:t>:</a:t>
            </a:r>
          </a:p>
          <a:p>
            <a:r>
              <a:rPr lang="en-US" dirty="0"/>
              <a:t>Low exponential phase M-CHO proteins, high exponential phase SP2/0 proteins levels</a:t>
            </a:r>
          </a:p>
        </p:txBody>
      </p:sp>
      <p:pic>
        <p:nvPicPr>
          <p:cNvPr id="8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91"/>
          <a:stretch>
            <a:fillRect/>
          </a:stretch>
        </p:blipFill>
        <p:spPr bwMode="auto">
          <a:xfrm>
            <a:off x="6506665" y="514527"/>
            <a:ext cx="5133955" cy="32710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6506666" y="3851339"/>
            <a:ext cx="58468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6. Actin cytoskeleton signalling pathway</a:t>
            </a:r>
          </a:p>
        </p:txBody>
      </p:sp>
    </p:spTree>
    <p:extLst>
      <p:ext uri="{BB962C8B-B14F-4D97-AF65-F5344CB8AC3E}">
        <p14:creationId xmlns:p14="http://schemas.microsoft.com/office/powerpoint/2010/main" val="29456418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eması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549</TotalTime>
  <Words>147</Words>
  <Application>Microsoft Office PowerPoint</Application>
  <PresentationFormat>Geniş ekran</PresentationFormat>
  <Paragraphs>22</Paragraphs>
  <Slides>5</Slides>
  <Notes>0</Notes>
  <HiddenSlides>0</HiddenSlides>
  <MMClips>0</MMClips>
  <ScaleCrop>false</ScaleCrop>
  <HeadingPairs>
    <vt:vector size="6" baseType="variant">
      <vt:variant>
        <vt:lpstr>Kullanılan Yazı Tipleri</vt:lpstr>
      </vt:variant>
      <vt:variant>
        <vt:i4>3</vt:i4>
      </vt:variant>
      <vt:variant>
        <vt:lpstr>Tema</vt:lpstr>
      </vt:variant>
      <vt:variant>
        <vt:i4>1</vt:i4>
      </vt:variant>
      <vt:variant>
        <vt:lpstr>Slayt Başlıkları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eması</vt:lpstr>
      <vt:lpstr>PowerPoint Sunusu</vt:lpstr>
      <vt:lpstr>PowerPoint Sunusu</vt:lpstr>
      <vt:lpstr>PowerPoint Sunusu</vt:lpstr>
      <vt:lpstr>PowerPoint Sunusu</vt:lpstr>
      <vt:lpstr>PowerPoint Sunusu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Sunusu</dc:title>
  <dc:creator>Deniz Bayçın</dc:creator>
  <cp:lastModifiedBy>Deniz Bayçın</cp:lastModifiedBy>
  <cp:revision>6</cp:revision>
  <dcterms:created xsi:type="dcterms:W3CDTF">2021-05-15T16:27:17Z</dcterms:created>
  <dcterms:modified xsi:type="dcterms:W3CDTF">2021-11-29T12:39:21Z</dcterms:modified>
</cp:coreProperties>
</file>